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6537"/>
    <p:restoredTop sz="94670"/>
  </p:normalViewPr>
  <p:slideViewPr>
    <p:cSldViewPr snapToGrid="0" snapToObjects="1">
      <p:cViewPr varScale="1">
        <p:scale>
          <a:sx n="99" d="100"/>
          <a:sy n="99" d="100"/>
        </p:scale>
        <p:origin x="200" y="15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5BE33DE-917F-8740-ACA0-F91FFFE0EB2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3FF7AD80-50B9-ED46-B6A3-A56E30ACD3B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B269137E-D42A-0042-9D94-5CFE80AD9A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8E902-2C8B-E149-ABBE-69B6A69F0353}" type="datetimeFigureOut">
              <a:rPr lang="en-US" smtClean="0"/>
              <a:t>7/12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DEA76CEC-8736-2B4C-B10F-6927E2FA78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00038F44-6328-BE4B-856C-B9D26499F7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E7613F-A067-EC43-82EE-5EC5458B92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78132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6DABE1D-8CC1-9247-97DD-11F1845A57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698509EB-C715-A944-95AE-05D4D42CFFE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4983F140-B014-B34D-9432-E4E338B65D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8E902-2C8B-E149-ABBE-69B6A69F0353}" type="datetimeFigureOut">
              <a:rPr lang="en-US" smtClean="0"/>
              <a:t>7/12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7588729E-D407-AD41-BE18-D73C32F991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1C73CC9B-BA8E-874D-879F-A05CF05AF0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E7613F-A067-EC43-82EE-5EC5458B92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44869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9921B9BD-4552-9F43-8D07-E88B4980E8A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038439E9-6B4D-C447-82C6-6F1E0E090B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D4723F56-BE10-184D-B599-F95299F0E5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8E902-2C8B-E149-ABBE-69B6A69F0353}" type="datetimeFigureOut">
              <a:rPr lang="en-US" smtClean="0"/>
              <a:t>7/12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A34055F0-AB31-2A42-9FB7-1F7981F6CA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0A97C4CA-29B9-7D4F-929A-FBA8837D4A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E7613F-A067-EC43-82EE-5EC5458B92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73934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B152530-4728-9448-9C4E-B4606C1C84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4CD34DB7-A1AB-0049-AAA7-27712FCB3F7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F6D85613-B6BD-A84F-9A19-25B8C6527E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8E902-2C8B-E149-ABBE-69B6A69F0353}" type="datetimeFigureOut">
              <a:rPr lang="en-US" smtClean="0"/>
              <a:t>7/12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73ACAAE1-4202-034C-80D5-FF215EC7C5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A623DBD4-E0EE-714F-AD47-2D2736172A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E7613F-A067-EC43-82EE-5EC5458B92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87915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A6D1B60-378C-984A-8881-2D4E284D9B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FB277CC1-6F7D-5B44-A34B-08158E539C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57C92C90-9A9C-E242-B96F-39DA030094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8E902-2C8B-E149-ABBE-69B6A69F0353}" type="datetimeFigureOut">
              <a:rPr lang="en-US" smtClean="0"/>
              <a:t>7/12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B6D2A856-5BB3-2D40-B88A-B31B769FF0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E777CE25-14D4-B840-8639-E56C8BFA2A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E7613F-A067-EC43-82EE-5EC5458B92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20726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3E21753-CF55-1344-879B-862681F17B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15CE4A8E-2DB6-194B-8E3F-C3410C0D8F0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702FFCE4-7643-EC41-9849-86359DDED49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85453E2B-E4B3-6143-B1F0-11CBAA2D37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8E902-2C8B-E149-ABBE-69B6A69F0353}" type="datetimeFigureOut">
              <a:rPr lang="en-US" smtClean="0"/>
              <a:t>7/12/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BDE2CA4D-65B3-194B-8941-1E8B6B9168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9688C3AB-D172-5B4B-B4AF-6094F05AED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E7613F-A067-EC43-82EE-5EC5458B92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93698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1316544-14C4-B849-A3F9-B3AE7530B5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FA88B867-9087-D34B-8631-56FD5E9D3F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933CD0BA-9011-1E4A-A522-1D3FCDCB4DB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F6B5BCEF-8819-724D-AFD3-EF957D17BB9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49560503-E5BC-A540-BE62-271BFBBB275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A6D10F30-083A-CB43-A935-719AD9C86A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8E902-2C8B-E149-ABBE-69B6A69F0353}" type="datetimeFigureOut">
              <a:rPr lang="en-US" smtClean="0"/>
              <a:t>7/12/18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BFE8B0F2-F966-014F-AE36-9A778691D6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99E78BEA-2AC0-A647-A529-3D4AAC7048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E7613F-A067-EC43-82EE-5EC5458B92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65621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2F2AD3F-15E6-4B49-9161-19916930CB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70F17E6A-E0C8-D745-ADFE-5692485EFD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8E902-2C8B-E149-ABBE-69B6A69F0353}" type="datetimeFigureOut">
              <a:rPr lang="en-US" smtClean="0"/>
              <a:t>7/12/18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E0D32E09-D93C-3543-A5BA-943B4AEBC6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F93833CB-AEAB-7241-8F60-E6CCB5856D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E7613F-A067-EC43-82EE-5EC5458B92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75936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7F98F6D5-E683-504D-A23C-3C3EEECADE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8E902-2C8B-E149-ABBE-69B6A69F0353}" type="datetimeFigureOut">
              <a:rPr lang="en-US" smtClean="0"/>
              <a:t>7/12/18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CC9F821C-1217-6B4A-BAC0-056E4D6E9F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DA41C1FC-BEBE-7242-AC3C-0DD8A1A9A1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E7613F-A067-EC43-82EE-5EC5458B92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8783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D9A9EC1-CF6B-094F-83FB-25F97A7DA9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E0683C2E-7704-2D4D-A3C6-13B6943929D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F5E3F099-C80C-A849-8F0C-328A771914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4B1B5904-4412-784F-80E4-3997CF12E3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8E902-2C8B-E149-ABBE-69B6A69F0353}" type="datetimeFigureOut">
              <a:rPr lang="en-US" smtClean="0"/>
              <a:t>7/12/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58F7E4AB-EF1E-8544-9309-60093E2D11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78E87618-9062-AA43-938D-B0338FC766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E7613F-A067-EC43-82EE-5EC5458B92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45864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64C8BB2-1C48-A54A-A424-7C2730EDB0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FDDCFF11-0CD7-E34F-803C-7722A571D54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245C4E7E-6587-FE41-9D4A-FDF3D2397EE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C6E1204B-126F-BC4A-9231-14287CB76C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A8E902-2C8B-E149-ABBE-69B6A69F0353}" type="datetimeFigureOut">
              <a:rPr lang="en-US" smtClean="0"/>
              <a:t>7/12/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57569DF5-01F7-974C-845A-17FF57006D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5E1F2087-7F37-D449-B6B7-A6714B851F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E7613F-A067-EC43-82EE-5EC5458B92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71433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DE067FF2-60AC-E34B-818A-49B2758313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D00D541F-3D9C-124A-B2D4-78920EE3DF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31D9DF70-4AD0-984C-A556-14EC1352A82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A8E902-2C8B-E149-ABBE-69B6A69F0353}" type="datetimeFigureOut">
              <a:rPr lang="en-US" smtClean="0"/>
              <a:t>7/12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6506279-6257-E741-B9F4-045A6293420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A1D7A8FD-56E9-944A-B9D0-67B442089AF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E7613F-A067-EC43-82EE-5EC5458B92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4862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xmlns="" id="{AF16379C-F1E7-A547-82F6-6F54834A3B5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6883056"/>
              </p:ext>
            </p:extLst>
          </p:nvPr>
        </p:nvGraphicFramePr>
        <p:xfrm>
          <a:off x="741317" y="1660080"/>
          <a:ext cx="10591797" cy="3602511"/>
        </p:xfrm>
        <a:graphic>
          <a:graphicData uri="http://schemas.openxmlformats.org/drawingml/2006/table">
            <a:tbl>
              <a:tblPr/>
              <a:tblGrid>
                <a:gridCol w="2573430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2319698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856181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185182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1235086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1422220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</a:tblGrid>
              <a:tr h="22934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Measurement (mm)</a:t>
                      </a:r>
                    </a:p>
                  </a:txBody>
                  <a:tcPr marL="9693" marR="9693" marT="969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Definition</a:t>
                      </a:r>
                    </a:p>
                  </a:txBody>
                  <a:tcPr marL="9693" marR="9693" marT="969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WT ±SD</a:t>
                      </a:r>
                    </a:p>
                  </a:txBody>
                  <a:tcPr marL="9693" marR="9693" marT="969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1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FoxO6</a:t>
                      </a:r>
                      <a:r>
                        <a:rPr lang="en-US" sz="1400" b="1" i="1" u="none" strike="noStrike" baseline="30000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-/- </a:t>
                      </a:r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±SD</a:t>
                      </a:r>
                    </a:p>
                  </a:txBody>
                  <a:tcPr marL="9693" marR="9693" marT="969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% increase</a:t>
                      </a:r>
                    </a:p>
                  </a:txBody>
                  <a:tcPr marL="9693" marR="9693" marT="969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p value</a:t>
                      </a:r>
                    </a:p>
                  </a:txBody>
                  <a:tcPr marL="9693" marR="9693" marT="9693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22934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err="1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Posterial</a:t>
                      </a:r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 Cranial Base Length </a:t>
                      </a:r>
                    </a:p>
                  </a:txBody>
                  <a:tcPr marL="9693" marR="9693" marT="969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err="1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midsphenoidal</a:t>
                      </a:r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 </a:t>
                      </a:r>
                      <a:r>
                        <a:rPr lang="en-US" sz="1400" b="1" i="0" u="none" strike="noStrike" dirty="0" err="1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synchondrosis-basion</a:t>
                      </a:r>
                      <a:endParaRPr lang="en-US" sz="1400" b="1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693" marR="9693" marT="969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6.8±0.14</a:t>
                      </a:r>
                    </a:p>
                  </a:txBody>
                  <a:tcPr marL="9693" marR="9693" marT="969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7.54±0.26</a:t>
                      </a:r>
                    </a:p>
                  </a:txBody>
                  <a:tcPr marL="9693" marR="9693" marT="969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10.90%</a:t>
                      </a:r>
                    </a:p>
                  </a:txBody>
                  <a:tcPr marL="9693" marR="9693" marT="969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0.012</a:t>
                      </a:r>
                    </a:p>
                  </a:txBody>
                  <a:tcPr marL="9693" marR="9693" marT="9693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2934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Palate Length</a:t>
                      </a:r>
                    </a:p>
                  </a:txBody>
                  <a:tcPr marL="9693" marR="9693" marT="969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Prosthion-PNS</a:t>
                      </a:r>
                    </a:p>
                  </a:txBody>
                  <a:tcPr marL="9693" marR="9693" marT="969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10.9±0.19</a:t>
                      </a:r>
                    </a:p>
                  </a:txBody>
                  <a:tcPr marL="9693" marR="9693" marT="969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11.63±0.09</a:t>
                      </a:r>
                    </a:p>
                  </a:txBody>
                  <a:tcPr marL="9693" marR="9693" marT="969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6.65%</a:t>
                      </a:r>
                    </a:p>
                  </a:txBody>
                  <a:tcPr marL="9693" marR="9693" marT="969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0.002</a:t>
                      </a:r>
                    </a:p>
                  </a:txBody>
                  <a:tcPr marL="9693" marR="9693" marT="9693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22934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Anterior cranial Base Length </a:t>
                      </a:r>
                    </a:p>
                  </a:txBody>
                  <a:tcPr marL="9693" marR="9693" marT="969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foramen cecum-</a:t>
                      </a:r>
                      <a:r>
                        <a:rPr lang="en-US" sz="1400" b="1" i="0" u="none" strike="noStrike" dirty="0" err="1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midsphenoidal</a:t>
                      </a:r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 </a:t>
                      </a:r>
                      <a:r>
                        <a:rPr lang="en-US" sz="1400" b="1" i="0" u="none" strike="noStrike" dirty="0" err="1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sychondrosis</a:t>
                      </a:r>
                      <a:endParaRPr lang="en-US" sz="1400" b="1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693" marR="9693" marT="969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6.30±0.05</a:t>
                      </a:r>
                    </a:p>
                  </a:txBody>
                  <a:tcPr marL="9693" marR="9693" marT="969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6.72±0.1</a:t>
                      </a:r>
                    </a:p>
                  </a:txBody>
                  <a:tcPr marL="9693" marR="9693" marT="969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6.65%</a:t>
                      </a:r>
                    </a:p>
                  </a:txBody>
                  <a:tcPr marL="9693" marR="9693" marT="969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0.003</a:t>
                      </a:r>
                    </a:p>
                  </a:txBody>
                  <a:tcPr marL="9693" marR="9693" marT="9693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22934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Upper Incisor Length(R)</a:t>
                      </a:r>
                    </a:p>
                  </a:txBody>
                  <a:tcPr marL="9693" marR="9693" marT="969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synchondrosis</a:t>
                      </a:r>
                    </a:p>
                  </a:txBody>
                  <a:tcPr marL="9693" marR="9693" marT="969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8.51±0.46</a:t>
                      </a:r>
                    </a:p>
                  </a:txBody>
                  <a:tcPr marL="9693" marR="9693" marT="969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8.96±0.45</a:t>
                      </a:r>
                    </a:p>
                  </a:txBody>
                  <a:tcPr marL="9693" marR="9693" marT="969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5.27%</a:t>
                      </a:r>
                    </a:p>
                  </a:txBody>
                  <a:tcPr marL="9693" marR="9693" marT="969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0.323</a:t>
                      </a:r>
                    </a:p>
                  </a:txBody>
                  <a:tcPr marL="9693" marR="9693" marT="9693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22934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Cranial Length</a:t>
                      </a:r>
                    </a:p>
                  </a:txBody>
                  <a:tcPr marL="9693" marR="9693" marT="969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err="1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Nasion-Opisth</a:t>
                      </a:r>
                      <a:endParaRPr lang="en-US" sz="1400" b="1" i="0" u="none" strike="noStrike" dirty="0">
                        <a:solidFill>
                          <a:schemeClr val="tx1"/>
                        </a:solidFill>
                        <a:effectLst/>
                        <a:latin typeface="Helvetica" pitchFamily="2" charset="0"/>
                      </a:endParaRPr>
                    </a:p>
                  </a:txBody>
                  <a:tcPr marL="9693" marR="9693" marT="969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15.65±0.25</a:t>
                      </a:r>
                    </a:p>
                  </a:txBody>
                  <a:tcPr marL="9693" marR="9693" marT="969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16.4±0.15</a:t>
                      </a:r>
                    </a:p>
                  </a:txBody>
                  <a:tcPr marL="9693" marR="9693" marT="969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4.79%</a:t>
                      </a:r>
                    </a:p>
                  </a:txBody>
                  <a:tcPr marL="9693" marR="9693" marT="969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0.009</a:t>
                      </a:r>
                    </a:p>
                  </a:txBody>
                  <a:tcPr marL="9693" marR="9693" marT="9693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22934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Lower Incisor length(R) </a:t>
                      </a:r>
                    </a:p>
                  </a:txBody>
                  <a:tcPr marL="9693" marR="9693" marT="969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Outer Perimeter</a:t>
                      </a:r>
                    </a:p>
                  </a:txBody>
                  <a:tcPr marL="9693" marR="9693" marT="969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11.61±0.18</a:t>
                      </a:r>
                    </a:p>
                  </a:txBody>
                  <a:tcPr marL="9693" marR="9693" marT="969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12.12±0.05</a:t>
                      </a:r>
                    </a:p>
                  </a:txBody>
                  <a:tcPr marL="9693" marR="9693" marT="969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4.21%</a:t>
                      </a:r>
                    </a:p>
                  </a:txBody>
                  <a:tcPr marL="9693" marR="9693" marT="969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</a:rPr>
                        <a:t>0.014</a:t>
                      </a:r>
                    </a:p>
                  </a:txBody>
                  <a:tcPr marL="9693" marR="9693" marT="9693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22934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Calibri" panose="020F0502020204030204" pitchFamily="34" charset="0"/>
                        </a:rPr>
                        <a:t>Lower M1 Breadth (R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Calibri" panose="020F0502020204030204" pitchFamily="34" charset="0"/>
                        </a:rPr>
                        <a:t>Max Breadth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Calibri" panose="020F0502020204030204" pitchFamily="34" charset="0"/>
                        </a:rPr>
                        <a:t>0.86±0.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Calibri" panose="020F0502020204030204" pitchFamily="34" charset="0"/>
                        </a:rPr>
                        <a:t>0.90±0.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Calibri" panose="020F0502020204030204" pitchFamily="34" charset="0"/>
                        </a:rPr>
                        <a:t>4.36%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Calibri" panose="020F0502020204030204" pitchFamily="34" charset="0"/>
                        </a:rPr>
                        <a:t>0.0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22934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Calibri" panose="020F0502020204030204" pitchFamily="34" charset="0"/>
                        </a:rPr>
                        <a:t>Upper M1 Breadth (R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Calibri" panose="020F0502020204030204" pitchFamily="34" charset="0"/>
                        </a:rPr>
                        <a:t>Max Breadth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Calibri" panose="020F0502020204030204" pitchFamily="34" charset="0"/>
                        </a:rPr>
                        <a:t>1.10±0.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Calibri" panose="020F0502020204030204" pitchFamily="34" charset="0"/>
                        </a:rPr>
                        <a:t>1.13±0.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Calibri" panose="020F0502020204030204" pitchFamily="34" charset="0"/>
                        </a:rPr>
                        <a:t>1.88%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Calibri" panose="020F0502020204030204" pitchFamily="34" charset="0"/>
                        </a:rPr>
                        <a:t>0.1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21375049"/>
                  </a:ext>
                </a:extLst>
              </a:tr>
              <a:tr h="22934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Calibri" panose="020F0502020204030204" pitchFamily="34" charset="0"/>
                        </a:rPr>
                        <a:t>Lower M2 Length (R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Calibri" panose="020F0502020204030204" pitchFamily="34" charset="0"/>
                        </a:rPr>
                        <a:t>Max length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Calibri" panose="020F0502020204030204" pitchFamily="34" charset="0"/>
                        </a:rPr>
                        <a:t>0.92±0.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Calibri" panose="020F0502020204030204" pitchFamily="34" charset="0"/>
                        </a:rPr>
                        <a:t>0.94±0.0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Calibri" panose="020F0502020204030204" pitchFamily="34" charset="0"/>
                        </a:rPr>
                        <a:t>1.81%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Calibri" panose="020F0502020204030204" pitchFamily="34" charset="0"/>
                        </a:rPr>
                        <a:t>0.3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22934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Calibri" panose="020F0502020204030204" pitchFamily="34" charset="0"/>
                        </a:rPr>
                        <a:t>Upper M2 Length (R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Calibri" panose="020F0502020204030204" pitchFamily="34" charset="0"/>
                        </a:rPr>
                        <a:t>Max length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Calibri" panose="020F0502020204030204" pitchFamily="34" charset="0"/>
                        </a:rPr>
                        <a:t>0.94±0.0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Calibri" panose="020F0502020204030204" pitchFamily="34" charset="0"/>
                        </a:rPr>
                        <a:t>0.96±0.0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Calibri" panose="020F0502020204030204" pitchFamily="34" charset="0"/>
                        </a:rPr>
                        <a:t>1.50%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Calibri" panose="020F0502020204030204" pitchFamily="34" charset="0"/>
                        </a:rPr>
                        <a:t>0.7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22934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Calibri" panose="020F0502020204030204" pitchFamily="34" charset="0"/>
                        </a:rPr>
                        <a:t>Lower M1 Length (R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Calibri" panose="020F0502020204030204" pitchFamily="34" charset="0"/>
                        </a:rPr>
                        <a:t>Max length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Calibri" panose="020F0502020204030204" pitchFamily="34" charset="0"/>
                        </a:rPr>
                        <a:t>1.47±0.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Calibri" panose="020F0502020204030204" pitchFamily="34" charset="0"/>
                        </a:rPr>
                        <a:t>1.49±0.0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Calibri" panose="020F0502020204030204" pitchFamily="34" charset="0"/>
                        </a:rPr>
                        <a:t>0.96%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Calibri" panose="020F0502020204030204" pitchFamily="34" charset="0"/>
                        </a:rPr>
                        <a:t>0.6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Calibri" panose="020F0502020204030204" pitchFamily="34" charset="0"/>
                        </a:rPr>
                        <a:t>Upper M1 Length (R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Calibri" panose="020F0502020204030204" pitchFamily="34" charset="0"/>
                        </a:rPr>
                        <a:t>Max length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Calibri" panose="020F0502020204030204" pitchFamily="34" charset="0"/>
                        </a:rPr>
                        <a:t>1.66±0.0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Calibri" panose="020F0502020204030204" pitchFamily="34" charset="0"/>
                        </a:rPr>
                        <a:t>1.67±0.0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Calibri" panose="020F0502020204030204" pitchFamily="34" charset="0"/>
                        </a:rPr>
                        <a:t>0.55%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Helvetica" pitchFamily="2" charset="0"/>
                          <a:cs typeface="Calibri" panose="020F0502020204030204" pitchFamily="34" charset="0"/>
                        </a:rPr>
                        <a:t>0.6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695008507"/>
                  </a:ext>
                </a:extLst>
              </a:tr>
            </a:tbl>
          </a:graphicData>
        </a:graphic>
      </p:graphicFrame>
      <p:sp>
        <p:nvSpPr>
          <p:cNvPr id="5" name="Rectangle 4">
            <a:extLst>
              <a:ext uri="{FF2B5EF4-FFF2-40B4-BE49-F238E27FC236}">
                <a16:creationId xmlns:a16="http://schemas.microsoft.com/office/drawing/2014/main" xmlns="" id="{B5D6B75E-21D8-AE4B-B8A6-A621A7535347}"/>
              </a:ext>
            </a:extLst>
          </p:cNvPr>
          <p:cNvSpPr/>
          <p:nvPr/>
        </p:nvSpPr>
        <p:spPr>
          <a:xfrm>
            <a:off x="657860" y="1221766"/>
            <a:ext cx="6606539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Helvetica" pitchFamily="2" charset="0"/>
              </a:rPr>
              <a:t>Table 1: Measurements and % change between WT and </a:t>
            </a:r>
            <a:r>
              <a:rPr lang="en-US" sz="1400" b="1" i="1" dirty="0">
                <a:latin typeface="Helvetica" pitchFamily="2" charset="0"/>
              </a:rPr>
              <a:t>FoxO6</a:t>
            </a:r>
            <a:r>
              <a:rPr lang="en-US" sz="1400" b="1" i="1" baseline="30000" dirty="0">
                <a:latin typeface="Helvetica" pitchFamily="2" charset="0"/>
              </a:rPr>
              <a:t>-/- </a:t>
            </a:r>
            <a:r>
              <a:rPr lang="en-US" sz="1400" b="1" dirty="0">
                <a:latin typeface="Helvetica" pitchFamily="2" charset="0"/>
              </a:rPr>
              <a:t>mice; N=4</a:t>
            </a:r>
            <a:endParaRPr lang="en-US" sz="1400" b="1" dirty="0">
              <a:latin typeface="Helvetica" pitchFamily="2" charset="0"/>
              <a:cs typeface="Helvetica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2A23D9EB-F9C7-154B-B414-5E9BFD6C16B8}"/>
              </a:ext>
            </a:extLst>
          </p:cNvPr>
          <p:cNvSpPr txBox="1"/>
          <p:nvPr/>
        </p:nvSpPr>
        <p:spPr>
          <a:xfrm>
            <a:off x="9118242" y="583658"/>
            <a:ext cx="20407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Helvetica"/>
                <a:cs typeface="Helvetica"/>
              </a:rPr>
              <a:t>Sun </a:t>
            </a:r>
            <a:r>
              <a:rPr lang="en-US" sz="1200" b="1" i="1" dirty="0">
                <a:latin typeface="Helvetica"/>
                <a:cs typeface="Helvetica"/>
              </a:rPr>
              <a:t>et al. </a:t>
            </a:r>
            <a:r>
              <a:rPr lang="en-US" sz="1200" b="1" i="1" dirty="0" smtClean="0">
                <a:latin typeface="Helvetica"/>
                <a:cs typeface="Helvetica"/>
              </a:rPr>
              <a:t>Suppl. </a:t>
            </a:r>
            <a:r>
              <a:rPr lang="en-US" sz="1200" b="1" dirty="0" smtClean="0">
                <a:latin typeface="Helvetica"/>
                <a:cs typeface="Helvetica"/>
              </a:rPr>
              <a:t>Table </a:t>
            </a:r>
            <a:r>
              <a:rPr lang="en-US" sz="1200" b="1" dirty="0">
                <a:latin typeface="Helvetica"/>
                <a:cs typeface="Helvetica"/>
              </a:rPr>
              <a:t>1.</a:t>
            </a:r>
          </a:p>
        </p:txBody>
      </p:sp>
    </p:spTree>
    <p:extLst>
      <p:ext uri="{BB962C8B-B14F-4D97-AF65-F5344CB8AC3E}">
        <p14:creationId xmlns:p14="http://schemas.microsoft.com/office/powerpoint/2010/main" val="35632131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178</Words>
  <Application>Microsoft Macintosh PowerPoint</Application>
  <PresentationFormat>Widescreen</PresentationFormat>
  <Paragraphs>8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owerPoint Presentation</vt:lpstr>
    </vt:vector>
  </TitlesOfParts>
  <Manager/>
  <Company/>
  <LinksUpToDate>false</LinksUpToDate>
  <SharedDoc>false</SharedDoc>
  <HyperlinkBase/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Amendt, Brad A</dc:creator>
  <cp:keywords/>
  <dc:description/>
  <cp:lastModifiedBy>Microsoft Office User</cp:lastModifiedBy>
  <cp:revision>4</cp:revision>
  <dcterms:created xsi:type="dcterms:W3CDTF">2018-07-11T01:33:07Z</dcterms:created>
  <dcterms:modified xsi:type="dcterms:W3CDTF">2018-07-12T22:29:01Z</dcterms:modified>
  <cp:category/>
</cp:coreProperties>
</file>